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7817B7-3FA5-41C6-BBB9-0CBB07118EA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19FCBD-2BFC-4700-A0AB-1218154BB9F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7CCAAA-4538-4F26-8B8D-B6D4CAC3C6F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F5E88F-E49B-4319-9464-C9C7A6C67F6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8B7928-6466-4D90-BE68-F1D86BBE121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50BA14-39A0-4718-82FA-232F6EEEFF4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544A96-D8DA-4FE5-BFF8-83BE8676B06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C7E957-31E0-4F8F-9252-3DBF4D43E63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2128E9-97D3-48B9-AE64-9ED2F932345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8B878A-2378-43EA-91A6-CE803BFFA4F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968034-17AC-44C3-9045-EFEBFECDC6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F2BA2E-E663-497C-9C9E-9E2BE714BE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C59763A-1042-47F3-8883-F5DA2615F7B3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uppo 9"/>
          <p:cNvGrpSpPr/>
          <p:nvPr/>
        </p:nvGrpSpPr>
        <p:grpSpPr>
          <a:xfrm>
            <a:off x="295200" y="235080"/>
            <a:ext cx="5510160" cy="5786280"/>
            <a:chOff x="295200" y="235080"/>
            <a:chExt cx="5510160" cy="5786280"/>
          </a:xfrm>
        </p:grpSpPr>
        <p:pic>
          <p:nvPicPr>
            <p:cNvPr id="42" name="Picture 2" descr=""/>
            <p:cNvPicPr/>
            <p:nvPr/>
          </p:nvPicPr>
          <p:blipFill>
            <a:blip r:embed="rId1"/>
            <a:srcRect l="13352" t="4647" r="0" b="58727"/>
            <a:stretch/>
          </p:blipFill>
          <p:spPr>
            <a:xfrm>
              <a:off x="316800" y="235080"/>
              <a:ext cx="5479200" cy="1852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Picture 3" descr=""/>
            <p:cNvPicPr/>
            <p:nvPr/>
          </p:nvPicPr>
          <p:blipFill>
            <a:blip r:embed="rId2"/>
            <a:srcRect l="13225" t="4455" r="301" b="57801"/>
            <a:stretch/>
          </p:blipFill>
          <p:spPr>
            <a:xfrm>
              <a:off x="312120" y="2152440"/>
              <a:ext cx="5479200" cy="1913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Picture 4" descr=""/>
            <p:cNvPicPr/>
            <p:nvPr/>
          </p:nvPicPr>
          <p:blipFill>
            <a:blip r:embed="rId3"/>
            <a:srcRect l="13178" t="4503" r="0" b="57495"/>
            <a:stretch/>
          </p:blipFill>
          <p:spPr>
            <a:xfrm>
              <a:off x="324720" y="4130280"/>
              <a:ext cx="5469480" cy="1891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5" name="Rettangolo 5"/>
            <p:cNvSpPr/>
            <p:nvPr/>
          </p:nvSpPr>
          <p:spPr>
            <a:xfrm>
              <a:off x="295200" y="236160"/>
              <a:ext cx="5510160" cy="1859040"/>
            </a:xfrm>
            <a:prstGeom prst="rect">
              <a:avLst/>
            </a:prstGeom>
            <a:noFill/>
            <a:ln w="25560">
              <a:solidFill>
                <a:srgbClr val="385d8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Rettangolo 7"/>
            <p:cNvSpPr/>
            <p:nvPr/>
          </p:nvSpPr>
          <p:spPr>
            <a:xfrm>
              <a:off x="295200" y="2145960"/>
              <a:ext cx="5510160" cy="1931040"/>
            </a:xfrm>
            <a:prstGeom prst="rect">
              <a:avLst/>
            </a:prstGeom>
            <a:noFill/>
            <a:ln w="25560">
              <a:solidFill>
                <a:srgbClr val="385d8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Rettangolo 8"/>
            <p:cNvSpPr/>
            <p:nvPr/>
          </p:nvSpPr>
          <p:spPr>
            <a:xfrm>
              <a:off x="295200" y="4130280"/>
              <a:ext cx="5510160" cy="1891080"/>
            </a:xfrm>
            <a:prstGeom prst="rect">
              <a:avLst/>
            </a:prstGeom>
            <a:noFill/>
            <a:ln w="25560">
              <a:solidFill>
                <a:srgbClr val="385d8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48" name="CasellaDiTesto 12"/>
          <p:cNvSpPr/>
          <p:nvPr/>
        </p:nvSpPr>
        <p:spPr>
          <a:xfrm>
            <a:off x="5838840" y="231840"/>
            <a:ext cx="3313080" cy="2284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Supplementary Figure 1: </a:t>
            </a:r>
            <a:r>
              <a:rPr b="0" lang="en-US" sz="1600" spc="-1" strike="noStrike" u="sng">
                <a:solidFill>
                  <a:srgbClr val="000000"/>
                </a:solidFill>
                <a:uFillTx/>
                <a:latin typeface="Calibri"/>
              </a:rPr>
              <a:t>Coverage comparison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For each panel (a-c), coverage of Agilent Sure Select XT (upper), Agilent HaloPlex Target Enrichment (middle) and MotorPlex (lower) on three different regions (a=NEB; b=RYR1; c=TTN) is shown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CasellaDiTesto 11"/>
          <p:cNvSpPr/>
          <p:nvPr/>
        </p:nvSpPr>
        <p:spPr>
          <a:xfrm>
            <a:off x="0" y="125280"/>
            <a:ext cx="324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CasellaDiTesto 12"/>
          <p:cNvSpPr/>
          <p:nvPr/>
        </p:nvSpPr>
        <p:spPr>
          <a:xfrm>
            <a:off x="6480" y="2060640"/>
            <a:ext cx="323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CasellaDiTesto 13"/>
          <p:cNvSpPr/>
          <p:nvPr/>
        </p:nvSpPr>
        <p:spPr>
          <a:xfrm>
            <a:off x="6480" y="4048200"/>
            <a:ext cx="323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7-30T12:12:20Z</dcterms:created>
  <dc:creator>LabN</dc:creator>
  <dc:description/>
  <dc:language>en-US</dc:language>
  <cp:lastModifiedBy>LabN</cp:lastModifiedBy>
  <dcterms:modified xsi:type="dcterms:W3CDTF">2014-07-30T12:14:21Z</dcterms:modified>
  <cp:revision>2</cp:revision>
  <dc:subject/>
  <dc:title>Diapositiva 1</dc:title>
</cp:coreProperties>
</file>